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  <p:sldId id="262" r:id="rId4"/>
    <p:sldId id="263" r:id="rId5"/>
  </p:sldIdLst>
  <p:sldSz cx="12192000" cy="6858000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F9000"/>
    <a:srgbClr val="99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225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Se&#353;it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cs-CZ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rgbClr val="CC00CC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E15-41BF-A6CB-2686512E7C85}"/>
              </c:ext>
            </c:extLst>
          </c:dPt>
          <c:dPt>
            <c:idx val="1"/>
            <c:bubble3D val="0"/>
            <c:spPr>
              <a:solidFill>
                <a:srgbClr val="CC99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E15-41BF-A6CB-2686512E7C85}"/>
              </c:ext>
            </c:extLst>
          </c:dPt>
          <c:dPt>
            <c:idx val="2"/>
            <c:bubble3D val="0"/>
            <c:spPr>
              <a:solidFill>
                <a:srgbClr val="FF99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E15-41BF-A6CB-2686512E7C85}"/>
              </c:ext>
            </c:extLst>
          </c:dPt>
          <c:dPt>
            <c:idx val="3"/>
            <c:bubble3D val="0"/>
            <c:spPr>
              <a:solidFill>
                <a:srgbClr val="9933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E15-41BF-A6CB-2686512E7C85}"/>
              </c:ext>
            </c:extLst>
          </c:dPt>
          <c:dPt>
            <c:idx val="4"/>
            <c:bubble3D val="0"/>
            <c:spPr>
              <a:solidFill>
                <a:srgbClr val="9966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E15-41BF-A6CB-2686512E7C85}"/>
              </c:ext>
            </c:extLst>
          </c:dPt>
          <c:dPt>
            <c:idx val="5"/>
            <c:bubble3D val="0"/>
            <c:spPr>
              <a:solidFill>
                <a:srgbClr val="7030A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0E15-41BF-A6CB-2686512E7C85}"/>
              </c:ext>
            </c:extLst>
          </c:dPt>
          <c:dPt>
            <c:idx val="6"/>
            <c:bubble3D val="0"/>
            <c:spPr>
              <a:solidFill>
                <a:srgbClr val="9900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0E15-41BF-A6CB-2686512E7C85}"/>
              </c:ext>
            </c:extLst>
          </c:dPt>
          <c:dPt>
            <c:idx val="7"/>
            <c:bubble3D val="0"/>
            <c:spPr>
              <a:solidFill>
                <a:srgbClr val="FFFF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0E15-41BF-A6CB-2686512E7C85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0E15-41BF-A6CB-2686512E7C85}"/>
              </c:ext>
            </c:extLst>
          </c:dPt>
          <c:dPt>
            <c:idx val="9"/>
            <c:bubble3D val="0"/>
            <c:spPr>
              <a:solidFill>
                <a:schemeClr val="accent4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0E15-41BF-A6CB-2686512E7C85}"/>
              </c:ext>
            </c:extLst>
          </c:dPt>
          <c:cat>
            <c:strRef>
              <c:f>List1!$A$1:$A$10</c:f>
              <c:strCache>
                <c:ptCount val="10"/>
                <c:pt idx="0">
                  <c:v>EOC ser LG</c:v>
                </c:pt>
                <c:pt idx="1">
                  <c:v>EOC mucin</c:v>
                </c:pt>
                <c:pt idx="2">
                  <c:v>EOC ser grade NA</c:v>
                </c:pt>
                <c:pt idx="3">
                  <c:v>EOC endom</c:v>
                </c:pt>
                <c:pt idx="4">
                  <c:v>EOC clear cell</c:v>
                </c:pt>
                <c:pt idx="5">
                  <c:v>EOC ser HG</c:v>
                </c:pt>
                <c:pt idx="6">
                  <c:v>EOC undifferentiated</c:v>
                </c:pt>
                <c:pt idx="7">
                  <c:v>NA</c:v>
                </c:pt>
                <c:pt idx="8">
                  <c:v>BTO</c:v>
                </c:pt>
                <c:pt idx="9">
                  <c:v>other</c:v>
                </c:pt>
              </c:strCache>
            </c:strRef>
          </c:cat>
          <c:val>
            <c:numRef>
              <c:f>List1!$B$1:$B$10</c:f>
              <c:numCache>
                <c:formatCode>General</c:formatCode>
                <c:ptCount val="10"/>
                <c:pt idx="0">
                  <c:v>22</c:v>
                </c:pt>
                <c:pt idx="1">
                  <c:v>15</c:v>
                </c:pt>
                <c:pt idx="2">
                  <c:v>11</c:v>
                </c:pt>
                <c:pt idx="3">
                  <c:v>6</c:v>
                </c:pt>
                <c:pt idx="4">
                  <c:v>3</c:v>
                </c:pt>
                <c:pt idx="5">
                  <c:v>2</c:v>
                </c:pt>
                <c:pt idx="6">
                  <c:v>2</c:v>
                </c:pt>
                <c:pt idx="7">
                  <c:v>17</c:v>
                </c:pt>
                <c:pt idx="8">
                  <c:v>30</c:v>
                </c:pt>
                <c:pt idx="9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0E15-41BF-A6CB-2686512E7C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cs-CZ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cs-CZ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D1353E21-C558-152F-8043-513D20A654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5706B7B7-7567-74B9-D6E9-3820AEAC42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29FF87AF-DD90-31EF-25DB-D8ED64DE6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D61-A821-4C22-B90A-979BD889061F}" type="datetimeFigureOut">
              <a:rPr lang="cs-CZ" smtClean="0"/>
              <a:t>11.06.2024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D4F26B6A-4907-9E21-A194-A264CA3E5D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130DBEDB-E051-8E5D-E20D-AB83F0C51F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454EC-E6B1-446D-B4DF-5A6DAB1534D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650171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E93AF06D-8955-C71F-A09B-0EAB1C65C3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25F9629F-B190-9D13-DCD4-7C2CDC019D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D683442C-D3DA-63FD-5D78-0F86D341E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D61-A821-4C22-B90A-979BD889061F}" type="datetimeFigureOut">
              <a:rPr lang="cs-CZ" smtClean="0"/>
              <a:t>11.06.2024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6D269200-B162-91EA-09DA-C25255031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C435630D-939E-0ED7-E33A-0B797D73E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454EC-E6B1-446D-B4DF-5A6DAB1534D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33225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>
            <a:extLst>
              <a:ext uri="{FF2B5EF4-FFF2-40B4-BE49-F238E27FC236}">
                <a16:creationId xmlns:a16="http://schemas.microsoft.com/office/drawing/2014/main" id="{45D5E088-EAAD-44FC-A0FB-94D5E3BBCD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A88F7343-F757-1457-6073-892DBDA80E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88053349-64C3-64F0-E285-7CB763983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D61-A821-4C22-B90A-979BD889061F}" type="datetimeFigureOut">
              <a:rPr lang="cs-CZ" smtClean="0"/>
              <a:t>11.06.2024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F2631D56-34DF-A615-761F-F17A774DC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7FD3E0CA-CE50-9EE5-05A4-3DB6A6FA3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454EC-E6B1-446D-B4DF-5A6DAB1534D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877844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D55D07D3-CEE0-8320-23B2-FAC1F4A6E3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AB08B23B-FE95-1A53-DC9F-75A662CE95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F3FCA816-AED2-5A9E-6E65-30E2A95F5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D61-A821-4C22-B90A-979BD889061F}" type="datetimeFigureOut">
              <a:rPr lang="cs-CZ" smtClean="0"/>
              <a:t>11.06.2024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0C271497-5CB5-A95B-F6FB-671EC8118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B117070-1B37-B89A-E146-5C9D347D8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454EC-E6B1-446D-B4DF-5A6DAB1534D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211376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6DE1C7A-062F-AE24-2E5D-2EA53E6E72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3C02DCCE-E87D-344F-B187-DA20149FDD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BE71A925-7940-DABC-FFC0-EEEDDEF15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D61-A821-4C22-B90A-979BD889061F}" type="datetimeFigureOut">
              <a:rPr lang="cs-CZ" smtClean="0"/>
              <a:t>11.06.2024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A1565222-93E4-5B40-9594-6AE3BBAF33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7C8992FE-A47E-34C5-FF96-5DD6B2E89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454EC-E6B1-446D-B4DF-5A6DAB1534D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935790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C3F0DC4C-1219-82DF-605D-C04739956A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53DDC5B3-013A-2314-60EC-8782979ACB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8AF8ACC1-178B-20A6-8CCA-EB7B98EC04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348B5B68-DF0E-E7D7-4B88-532BD15351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D61-A821-4C22-B90A-979BD889061F}" type="datetimeFigureOut">
              <a:rPr lang="cs-CZ" smtClean="0"/>
              <a:t>11.06.2024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295AA0EA-3A2B-ACB4-F747-7A5C9E1FC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E3BAFEED-BE8D-3F38-1754-AC06E0A0D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454EC-E6B1-446D-B4DF-5A6DAB1534D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28696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192AA46A-1CB7-5217-0065-4310A1D001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58F80510-1B6C-385F-5F59-957C5C6331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538CA287-E2AE-10E3-2369-9D83BF219C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8F6D1CB9-D8FF-F51F-A1EC-67B16B54BF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Zástupný obsah 5">
            <a:extLst>
              <a:ext uri="{FF2B5EF4-FFF2-40B4-BE49-F238E27FC236}">
                <a16:creationId xmlns:a16="http://schemas.microsoft.com/office/drawing/2014/main" id="{EB41C486-361A-E73D-68B0-2DA0F84A48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7" name="Zástupný symbol pro datum 6">
            <a:extLst>
              <a:ext uri="{FF2B5EF4-FFF2-40B4-BE49-F238E27FC236}">
                <a16:creationId xmlns:a16="http://schemas.microsoft.com/office/drawing/2014/main" id="{5C3CEBE7-9B0D-9D64-D33E-2FEB0A028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D61-A821-4C22-B90A-979BD889061F}" type="datetimeFigureOut">
              <a:rPr lang="cs-CZ" smtClean="0"/>
              <a:t>11.06.2024</a:t>
            </a:fld>
            <a:endParaRPr lang="cs-CZ"/>
          </a:p>
        </p:txBody>
      </p:sp>
      <p:sp>
        <p:nvSpPr>
          <p:cNvPr id="8" name="Zástupný symbol pro zápatí 7">
            <a:extLst>
              <a:ext uri="{FF2B5EF4-FFF2-40B4-BE49-F238E27FC236}">
                <a16:creationId xmlns:a16="http://schemas.microsoft.com/office/drawing/2014/main" id="{138ACB1D-CBF2-476F-4E86-797A5F447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>
            <a:extLst>
              <a:ext uri="{FF2B5EF4-FFF2-40B4-BE49-F238E27FC236}">
                <a16:creationId xmlns:a16="http://schemas.microsoft.com/office/drawing/2014/main" id="{C9070F1B-48A3-F11D-3138-5DC898A8B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454EC-E6B1-446D-B4DF-5A6DAB1534D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88438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CCE28579-55B7-2ED4-AFBE-89D1FF8536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datum 2">
            <a:extLst>
              <a:ext uri="{FF2B5EF4-FFF2-40B4-BE49-F238E27FC236}">
                <a16:creationId xmlns:a16="http://schemas.microsoft.com/office/drawing/2014/main" id="{E209118B-CA0C-80C6-9643-206CA65CB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D61-A821-4C22-B90A-979BD889061F}" type="datetimeFigureOut">
              <a:rPr lang="cs-CZ" smtClean="0"/>
              <a:t>11.06.2024</a:t>
            </a:fld>
            <a:endParaRPr lang="cs-CZ"/>
          </a:p>
        </p:txBody>
      </p:sp>
      <p:sp>
        <p:nvSpPr>
          <p:cNvPr id="4" name="Zástupný symbol pro zápatí 3">
            <a:extLst>
              <a:ext uri="{FF2B5EF4-FFF2-40B4-BE49-F238E27FC236}">
                <a16:creationId xmlns:a16="http://schemas.microsoft.com/office/drawing/2014/main" id="{D5CC1A4F-3EAB-B8B2-5B20-1420E18CF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>
            <a:extLst>
              <a:ext uri="{FF2B5EF4-FFF2-40B4-BE49-F238E27FC236}">
                <a16:creationId xmlns:a16="http://schemas.microsoft.com/office/drawing/2014/main" id="{6FD5DB9B-D23D-76C7-897E-DBB3DB8B90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454EC-E6B1-446D-B4DF-5A6DAB1534D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22075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>
            <a:extLst>
              <a:ext uri="{FF2B5EF4-FFF2-40B4-BE49-F238E27FC236}">
                <a16:creationId xmlns:a16="http://schemas.microsoft.com/office/drawing/2014/main" id="{03554B7B-B00E-A97E-D73A-232C2DC79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D61-A821-4C22-B90A-979BD889061F}" type="datetimeFigureOut">
              <a:rPr lang="cs-CZ" smtClean="0"/>
              <a:t>11.06.2024</a:t>
            </a:fld>
            <a:endParaRPr lang="cs-CZ"/>
          </a:p>
        </p:txBody>
      </p:sp>
      <p:sp>
        <p:nvSpPr>
          <p:cNvPr id="3" name="Zástupný symbol pro zápatí 2">
            <a:extLst>
              <a:ext uri="{FF2B5EF4-FFF2-40B4-BE49-F238E27FC236}">
                <a16:creationId xmlns:a16="http://schemas.microsoft.com/office/drawing/2014/main" id="{D5CB1804-1ED9-C1BE-96F5-477C80DDD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>
            <a:extLst>
              <a:ext uri="{FF2B5EF4-FFF2-40B4-BE49-F238E27FC236}">
                <a16:creationId xmlns:a16="http://schemas.microsoft.com/office/drawing/2014/main" id="{DB686C00-33AF-7062-D2F3-A3948AD09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454EC-E6B1-446D-B4DF-5A6DAB1534D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308091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EF65FAA1-08E6-A8DF-5C6C-ED3C3FF257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00084CC9-087F-09B5-CB59-CA7690F636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B0BA5175-F458-3FE2-0C53-912B9DD16A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F5BB378E-886C-2A2D-09B6-3764826D1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D61-A821-4C22-B90A-979BD889061F}" type="datetimeFigureOut">
              <a:rPr lang="cs-CZ" smtClean="0"/>
              <a:t>11.06.2024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2805ED9B-8097-38E7-241C-DCB1C48162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3BEA507B-8FFB-E6BE-C822-EE011D0FE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454EC-E6B1-446D-B4DF-5A6DAB1534D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13235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F68E4093-DF50-FCF0-884A-90FBC738BE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symbol obrázku 2">
            <a:extLst>
              <a:ext uri="{FF2B5EF4-FFF2-40B4-BE49-F238E27FC236}">
                <a16:creationId xmlns:a16="http://schemas.microsoft.com/office/drawing/2014/main" id="{15033D72-72CB-53BE-1881-9D86DC0A73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8BEC31FA-27EB-B300-43BB-499C9E6B6A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8D3B369D-0EEF-8FD5-AC13-D3C234A05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1CD61-A821-4C22-B90A-979BD889061F}" type="datetimeFigureOut">
              <a:rPr lang="cs-CZ" smtClean="0"/>
              <a:t>11.06.2024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E2B9CFF6-6F06-E581-1C3F-A04B05929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9D87C5E1-7E72-FD02-1169-00B9DC727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454EC-E6B1-446D-B4DF-5A6DAB1534D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0381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nadpis 1">
            <a:extLst>
              <a:ext uri="{FF2B5EF4-FFF2-40B4-BE49-F238E27FC236}">
                <a16:creationId xmlns:a16="http://schemas.microsoft.com/office/drawing/2014/main" id="{DF6B1FEC-3376-94D0-4C20-89CCF190D7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54C9B5B8-3952-46E0-D3A9-A3E6200238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819C93A8-F193-3576-2746-FF313CE9B1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41CD61-A821-4C22-B90A-979BD889061F}" type="datetimeFigureOut">
              <a:rPr lang="cs-CZ" smtClean="0"/>
              <a:t>11.06.2024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D8218263-0858-8BF0-AA93-945B35E780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C8DAD552-B9B0-017A-379A-7E08BAE61E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3454EC-E6B1-446D-B4DF-5A6DAB1534D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34473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Obrázek 35">
            <a:extLst>
              <a:ext uri="{FF2B5EF4-FFF2-40B4-BE49-F238E27FC236}">
                <a16:creationId xmlns:a16="http://schemas.microsoft.com/office/drawing/2014/main" id="{993A2CBE-352C-3F1F-CD00-2BA5F137F37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76"/>
          <a:stretch/>
        </p:blipFill>
        <p:spPr>
          <a:xfrm>
            <a:off x="1767880" y="4271799"/>
            <a:ext cx="8584635" cy="1913994"/>
          </a:xfrm>
          <a:prstGeom prst="rect">
            <a:avLst/>
          </a:prstGeom>
        </p:spPr>
      </p:pic>
      <p:sp>
        <p:nvSpPr>
          <p:cNvPr id="3" name="TextovéPole 2">
            <a:extLst>
              <a:ext uri="{FF2B5EF4-FFF2-40B4-BE49-F238E27FC236}">
                <a16:creationId xmlns:a16="http://schemas.microsoft.com/office/drawing/2014/main" id="{B0FD653B-0022-3599-91EE-4891894723E0}"/>
              </a:ext>
            </a:extLst>
          </p:cNvPr>
          <p:cNvSpPr txBox="1"/>
          <p:nvPr/>
        </p:nvSpPr>
        <p:spPr>
          <a:xfrm>
            <a:off x="457199" y="1012259"/>
            <a:ext cx="1856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:</a:t>
            </a:r>
          </a:p>
        </p:txBody>
      </p:sp>
      <p:sp>
        <p:nvSpPr>
          <p:cNvPr id="10" name="TextovéPole 9">
            <a:extLst>
              <a:ext uri="{FF2B5EF4-FFF2-40B4-BE49-F238E27FC236}">
                <a16:creationId xmlns:a16="http://schemas.microsoft.com/office/drawing/2014/main" id="{E91CCF23-D4A6-3859-27ED-FAC874E96518}"/>
              </a:ext>
            </a:extLst>
          </p:cNvPr>
          <p:cNvSpPr txBox="1"/>
          <p:nvPr/>
        </p:nvSpPr>
        <p:spPr>
          <a:xfrm>
            <a:off x="457198" y="3014843"/>
            <a:ext cx="18565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</a:t>
            </a:r>
            <a:b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cs-CZ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t</a:t>
            </a:r>
            <a: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ele</a:t>
            </a:r>
            <a: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</p:txBody>
      </p:sp>
      <p:pic>
        <p:nvPicPr>
          <p:cNvPr id="17" name="Obrázek 16">
            <a:extLst>
              <a:ext uri="{FF2B5EF4-FFF2-40B4-BE49-F238E27FC236}">
                <a16:creationId xmlns:a16="http://schemas.microsoft.com/office/drawing/2014/main" id="{0BE6F5AE-2CDB-E142-73B7-6418F89FA4C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793"/>
          <a:stretch/>
        </p:blipFill>
        <p:spPr>
          <a:xfrm>
            <a:off x="1734248" y="922618"/>
            <a:ext cx="8618268" cy="1223621"/>
          </a:xfrm>
          <a:prstGeom prst="rect">
            <a:avLst/>
          </a:prstGeom>
        </p:spPr>
      </p:pic>
      <p:grpSp>
        <p:nvGrpSpPr>
          <p:cNvPr id="34" name="Skupina 33">
            <a:extLst>
              <a:ext uri="{FF2B5EF4-FFF2-40B4-BE49-F238E27FC236}">
                <a16:creationId xmlns:a16="http://schemas.microsoft.com/office/drawing/2014/main" id="{CEEC44BC-ED0F-CFAD-18DF-7491A96938EA}"/>
              </a:ext>
            </a:extLst>
          </p:cNvPr>
          <p:cNvGrpSpPr/>
          <p:nvPr/>
        </p:nvGrpSpPr>
        <p:grpSpPr>
          <a:xfrm>
            <a:off x="1640632" y="2756678"/>
            <a:ext cx="9270899" cy="1324821"/>
            <a:chOff x="1640632" y="2321266"/>
            <a:chExt cx="10145727" cy="1597745"/>
          </a:xfrm>
        </p:grpSpPr>
        <p:pic>
          <p:nvPicPr>
            <p:cNvPr id="18" name="Obrázek 17">
              <a:extLst>
                <a:ext uri="{FF2B5EF4-FFF2-40B4-BE49-F238E27FC236}">
                  <a16:creationId xmlns:a16="http://schemas.microsoft.com/office/drawing/2014/main" id="{58811A77-881A-9E5A-0380-472E8E3131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67" t="2685" r="8737" b="-1"/>
            <a:stretch/>
          </p:blipFill>
          <p:spPr>
            <a:xfrm>
              <a:off x="1734248" y="2690598"/>
              <a:ext cx="9440345" cy="1194967"/>
            </a:xfrm>
            <a:prstGeom prst="rect">
              <a:avLst/>
            </a:prstGeom>
          </p:spPr>
        </p:pic>
        <p:cxnSp>
          <p:nvCxnSpPr>
            <p:cNvPr id="19" name="Přímá spojnice 18">
              <a:extLst>
                <a:ext uri="{FF2B5EF4-FFF2-40B4-BE49-F238E27FC236}">
                  <a16:creationId xmlns:a16="http://schemas.microsoft.com/office/drawing/2014/main" id="{7F482ED6-0A57-2C43-51FB-1F55DEC04258}"/>
                </a:ext>
              </a:extLst>
            </p:cNvPr>
            <p:cNvCxnSpPr/>
            <p:nvPr/>
          </p:nvCxnSpPr>
          <p:spPr>
            <a:xfrm>
              <a:off x="2277753" y="2637790"/>
              <a:ext cx="0" cy="124777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ovéPole 19">
              <a:extLst>
                <a:ext uri="{FF2B5EF4-FFF2-40B4-BE49-F238E27FC236}">
                  <a16:creationId xmlns:a16="http://schemas.microsoft.com/office/drawing/2014/main" id="{F3F28FF8-EC54-5B84-FEC6-33B6069DA13F}"/>
                </a:ext>
              </a:extLst>
            </p:cNvPr>
            <p:cNvSpPr txBox="1"/>
            <p:nvPr/>
          </p:nvSpPr>
          <p:spPr>
            <a:xfrm>
              <a:off x="1640632" y="2321266"/>
              <a:ext cx="2076628" cy="4454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13           i13 </a:t>
              </a:r>
            </a:p>
          </p:txBody>
        </p:sp>
        <p:cxnSp>
          <p:nvCxnSpPr>
            <p:cNvPr id="21" name="Přímá spojnice 20">
              <a:extLst>
                <a:ext uri="{FF2B5EF4-FFF2-40B4-BE49-F238E27FC236}">
                  <a16:creationId xmlns:a16="http://schemas.microsoft.com/office/drawing/2014/main" id="{90111B5D-EBAE-AF9C-8B72-B7A4D43A5C4F}"/>
                </a:ext>
              </a:extLst>
            </p:cNvPr>
            <p:cNvCxnSpPr/>
            <p:nvPr/>
          </p:nvCxnSpPr>
          <p:spPr>
            <a:xfrm>
              <a:off x="10586934" y="2671236"/>
              <a:ext cx="0" cy="124777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ovéPole 21">
              <a:extLst>
                <a:ext uri="{FF2B5EF4-FFF2-40B4-BE49-F238E27FC236}">
                  <a16:creationId xmlns:a16="http://schemas.microsoft.com/office/drawing/2014/main" id="{6C9AFE36-15F4-BF18-8C7B-BAD39CA533CF}"/>
                </a:ext>
              </a:extLst>
            </p:cNvPr>
            <p:cNvSpPr txBox="1"/>
            <p:nvPr/>
          </p:nvSpPr>
          <p:spPr>
            <a:xfrm>
              <a:off x="9709731" y="2347883"/>
              <a:ext cx="2076628" cy="4454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13           ex14 </a:t>
              </a:r>
            </a:p>
          </p:txBody>
        </p:sp>
      </p:grpSp>
      <p:sp>
        <p:nvSpPr>
          <p:cNvPr id="24" name="TextovéPole 23">
            <a:extLst>
              <a:ext uri="{FF2B5EF4-FFF2-40B4-BE49-F238E27FC236}">
                <a16:creationId xmlns:a16="http://schemas.microsoft.com/office/drawing/2014/main" id="{04BE1F8E-DFD9-EF26-F215-6D710D9266AA}"/>
              </a:ext>
            </a:extLst>
          </p:cNvPr>
          <p:cNvSpPr txBox="1"/>
          <p:nvPr/>
        </p:nvSpPr>
        <p:spPr>
          <a:xfrm>
            <a:off x="5993284" y="584064"/>
            <a:ext cx="18565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1461+2301G&gt;T</a:t>
            </a:r>
            <a:endParaRPr lang="cs-CZ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Šipka: dolů 24">
            <a:extLst>
              <a:ext uri="{FF2B5EF4-FFF2-40B4-BE49-F238E27FC236}">
                <a16:creationId xmlns:a16="http://schemas.microsoft.com/office/drawing/2014/main" id="{EB538701-EE25-E097-CAB8-6EC36C3D30CE}"/>
              </a:ext>
            </a:extLst>
          </p:cNvPr>
          <p:cNvSpPr/>
          <p:nvPr/>
        </p:nvSpPr>
        <p:spPr>
          <a:xfrm>
            <a:off x="6587412" y="889172"/>
            <a:ext cx="214604" cy="492419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ovéPole 27">
            <a:extLst>
              <a:ext uri="{FF2B5EF4-FFF2-40B4-BE49-F238E27FC236}">
                <a16:creationId xmlns:a16="http://schemas.microsoft.com/office/drawing/2014/main" id="{6243B0E2-7B11-4B41-6A49-157A21FC5053}"/>
              </a:ext>
            </a:extLst>
          </p:cNvPr>
          <p:cNvSpPr txBox="1"/>
          <p:nvPr/>
        </p:nvSpPr>
        <p:spPr>
          <a:xfrm>
            <a:off x="457197" y="4554044"/>
            <a:ext cx="185650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 </a:t>
            </a:r>
            <a:r>
              <a:rPr lang="cs-CZ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t</a:t>
            </a:r>
            <a: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:</a:t>
            </a:r>
          </a:p>
          <a:p>
            <a:endParaRPr lang="cs-CZ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cs-CZ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cs-CZ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 </a:t>
            </a:r>
            <a:r>
              <a:rPr lang="cs-CZ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rl</a:t>
            </a:r>
            <a: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</p:txBody>
      </p:sp>
      <p:sp>
        <p:nvSpPr>
          <p:cNvPr id="31" name="TextovéPole 30">
            <a:extLst>
              <a:ext uri="{FF2B5EF4-FFF2-40B4-BE49-F238E27FC236}">
                <a16:creationId xmlns:a16="http://schemas.microsoft.com/office/drawing/2014/main" id="{F0042E2A-E27F-F488-C77F-E08888088E13}"/>
              </a:ext>
            </a:extLst>
          </p:cNvPr>
          <p:cNvSpPr txBox="1"/>
          <p:nvPr/>
        </p:nvSpPr>
        <p:spPr>
          <a:xfrm>
            <a:off x="1830196" y="6228602"/>
            <a:ext cx="86562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15                          ex14                                                                                                                  ex13                  ex12</a:t>
            </a:r>
          </a:p>
        </p:txBody>
      </p:sp>
      <p:sp>
        <p:nvSpPr>
          <p:cNvPr id="32" name="Šipka: dolů 31">
            <a:extLst>
              <a:ext uri="{FF2B5EF4-FFF2-40B4-BE49-F238E27FC236}">
                <a16:creationId xmlns:a16="http://schemas.microsoft.com/office/drawing/2014/main" id="{FFBB2324-525C-8F8F-EA6A-31A60923BDDB}"/>
              </a:ext>
            </a:extLst>
          </p:cNvPr>
          <p:cNvSpPr/>
          <p:nvPr/>
        </p:nvSpPr>
        <p:spPr>
          <a:xfrm rot="3160794">
            <a:off x="6454742" y="4449989"/>
            <a:ext cx="191903" cy="246209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Šipka: dolů 36">
            <a:extLst>
              <a:ext uri="{FF2B5EF4-FFF2-40B4-BE49-F238E27FC236}">
                <a16:creationId xmlns:a16="http://schemas.microsoft.com/office/drawing/2014/main" id="{20BA7348-D3AF-6FC6-0978-C17038FD95E0}"/>
              </a:ext>
            </a:extLst>
          </p:cNvPr>
          <p:cNvSpPr/>
          <p:nvPr/>
        </p:nvSpPr>
        <p:spPr>
          <a:xfrm rot="3160794">
            <a:off x="9726776" y="2767297"/>
            <a:ext cx="191903" cy="246209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ovéPole 53">
            <a:extLst>
              <a:ext uri="{FF2B5EF4-FFF2-40B4-BE49-F238E27FC236}">
                <a16:creationId xmlns:a16="http://schemas.microsoft.com/office/drawing/2014/main" id="{137562A1-FB23-36F4-9D0E-66710612AEAF}"/>
              </a:ext>
            </a:extLst>
          </p:cNvPr>
          <p:cNvSpPr txBox="1"/>
          <p:nvPr/>
        </p:nvSpPr>
        <p:spPr>
          <a:xfrm>
            <a:off x="167466" y="1012259"/>
            <a:ext cx="1856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56" name="TextovéPole 55">
            <a:extLst>
              <a:ext uri="{FF2B5EF4-FFF2-40B4-BE49-F238E27FC236}">
                <a16:creationId xmlns:a16="http://schemas.microsoft.com/office/drawing/2014/main" id="{D4DDD229-9C4B-A387-A4DB-C309E2B09FB1}"/>
              </a:ext>
            </a:extLst>
          </p:cNvPr>
          <p:cNvSpPr txBox="1"/>
          <p:nvPr/>
        </p:nvSpPr>
        <p:spPr>
          <a:xfrm>
            <a:off x="186513" y="3013830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57" name="TextovéPole 56">
            <a:extLst>
              <a:ext uri="{FF2B5EF4-FFF2-40B4-BE49-F238E27FC236}">
                <a16:creationId xmlns:a16="http://schemas.microsoft.com/office/drawing/2014/main" id="{9DDABE89-F2F7-5A49-5ADC-F81ED25D8CAA}"/>
              </a:ext>
            </a:extLst>
          </p:cNvPr>
          <p:cNvSpPr txBox="1"/>
          <p:nvPr/>
        </p:nvSpPr>
        <p:spPr>
          <a:xfrm>
            <a:off x="167466" y="455404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cs-CZ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sp>
        <p:nvSpPr>
          <p:cNvPr id="23" name="Obdélník 22">
            <a:extLst>
              <a:ext uri="{FF2B5EF4-FFF2-40B4-BE49-F238E27FC236}">
                <a16:creationId xmlns:a16="http://schemas.microsoft.com/office/drawing/2014/main" id="{0FB451C9-43FF-4510-8E67-E12E7A26CC42}"/>
              </a:ext>
            </a:extLst>
          </p:cNvPr>
          <p:cNvSpPr/>
          <p:nvPr/>
        </p:nvSpPr>
        <p:spPr>
          <a:xfrm>
            <a:off x="113298" y="22258"/>
            <a:ext cx="11799127" cy="11387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</a:t>
            </a:r>
            <a:r>
              <a:rPr lang="cs-CZ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zation of the novel c.1461+2301G&gt;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K2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licing GPV: at the DNA level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at the RNA level using RT-PCR/Sanger sequencing with the variant specific reverse primer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; Visualization of the RNA event; 3’ of the novel exon is marked by the arrow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 </a:t>
            </a:r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endParaRPr lang="cs-CZ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cs-CZ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Obdélník 1">
            <a:extLst>
              <a:ext uri="{FF2B5EF4-FFF2-40B4-BE49-F238E27FC236}">
                <a16:creationId xmlns:a16="http://schemas.microsoft.com/office/drawing/2014/main" id="{01C320BA-CFD2-4C4C-89D8-757A5D9411A6}"/>
              </a:ext>
            </a:extLst>
          </p:cNvPr>
          <p:cNvSpPr/>
          <p:nvPr/>
        </p:nvSpPr>
        <p:spPr>
          <a:xfrm>
            <a:off x="10486436" y="5036700"/>
            <a:ext cx="6096000" cy="1077218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trl, control sample; </a:t>
            </a:r>
            <a:endParaRPr lang="cs-CZ" sz="1100" i="1" kern="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, exon; </a:t>
            </a:r>
            <a:r>
              <a:rPr lang="en-US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intron; </a:t>
            </a:r>
            <a:endParaRPr lang="cs-CZ" sz="1100" i="1" kern="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t</a:t>
            </a:r>
            <a:r>
              <a:rPr lang="en-US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utated; </a:t>
            </a:r>
            <a:endParaRPr lang="cs-CZ" sz="1100" i="1" kern="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t</a:t>
            </a:r>
            <a:r>
              <a:rPr lang="en-US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wildtype.</a:t>
            </a:r>
            <a:endParaRPr lang="cs-CZ" sz="1100" kern="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6" name="Obdélník 25">
            <a:extLst>
              <a:ext uri="{FF2B5EF4-FFF2-40B4-BE49-F238E27FC236}">
                <a16:creationId xmlns:a16="http://schemas.microsoft.com/office/drawing/2014/main" id="{451FC314-D8FC-4678-B3AC-5560956FA53E}"/>
              </a:ext>
            </a:extLst>
          </p:cNvPr>
          <p:cNvSpPr/>
          <p:nvPr/>
        </p:nvSpPr>
        <p:spPr>
          <a:xfrm>
            <a:off x="1769667" y="6579188"/>
            <a:ext cx="8209133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US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variant was present in 26% of reads in WES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om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NA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olated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omperipheral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ood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nhibited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onsense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diated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cay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cs-CZ" sz="1100" kern="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Obdélník 3">
            <a:extLst>
              <a:ext uri="{FF2B5EF4-FFF2-40B4-BE49-F238E27FC236}">
                <a16:creationId xmlns:a16="http://schemas.microsoft.com/office/drawing/2014/main" id="{E46CC198-CFC5-406B-A089-D77B9A457514}"/>
              </a:ext>
            </a:extLst>
          </p:cNvPr>
          <p:cNvSpPr/>
          <p:nvPr/>
        </p:nvSpPr>
        <p:spPr>
          <a:xfrm>
            <a:off x="2878987" y="2386491"/>
            <a:ext cx="59536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>
                <a:latin typeface="Times New Roman" panose="02020603050405020304" pitchFamily="18" charset="0"/>
                <a:ea typeface="Calibri" panose="020F0502020204030204" pitchFamily="34" charset="0"/>
              </a:rPr>
              <a:t>.1461_1462ins1461+2211_1461+2299</a:t>
            </a:r>
            <a:r>
              <a:rPr lang="cs-CZ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cs-CZ" dirty="0"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dirty="0"/>
              <a:t>p.Asp488SerfsTer34</a:t>
            </a:r>
            <a:r>
              <a:rPr lang="cs-CZ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0415961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>
            <a:extLst>
              <a:ext uri="{FF2B5EF4-FFF2-40B4-BE49-F238E27FC236}">
                <a16:creationId xmlns:a16="http://schemas.microsoft.com/office/drawing/2014/main" id="{47FF3F50-F0D0-4DAC-94ED-B57FCB1036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8595" y="1450166"/>
            <a:ext cx="5200605" cy="3568664"/>
          </a:xfrm>
          <a:prstGeom prst="rect">
            <a:avLst/>
          </a:prstGeom>
        </p:spPr>
      </p:pic>
      <p:sp>
        <p:nvSpPr>
          <p:cNvPr id="7" name="Obdélník 6">
            <a:extLst>
              <a:ext uri="{FF2B5EF4-FFF2-40B4-BE49-F238E27FC236}">
                <a16:creationId xmlns:a16="http://schemas.microsoft.com/office/drawing/2014/main" id="{BEAFE322-6BB8-4707-9E59-140262C4D76E}"/>
              </a:ext>
            </a:extLst>
          </p:cNvPr>
          <p:cNvSpPr/>
          <p:nvPr/>
        </p:nvSpPr>
        <p:spPr>
          <a:xfrm>
            <a:off x="2147646" y="5342693"/>
            <a:ext cx="94755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7                            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cs-CZ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Obdélník 7">
            <a:extLst>
              <a:ext uri="{FF2B5EF4-FFF2-40B4-BE49-F238E27FC236}">
                <a16:creationId xmlns:a16="http://schemas.microsoft.com/office/drawing/2014/main" id="{D2E06ADE-FAC4-4A92-B101-23DE9258B673}"/>
              </a:ext>
            </a:extLst>
          </p:cNvPr>
          <p:cNvSpPr/>
          <p:nvPr/>
        </p:nvSpPr>
        <p:spPr>
          <a:xfrm>
            <a:off x="113298" y="22258"/>
            <a:ext cx="11799127" cy="8925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</a:t>
            </a:r>
            <a:r>
              <a:rPr lang="cs-CZ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: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 at OC diagnosis in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K2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nd OC patients negative for HBOPC GPV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zed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viously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 (</a:t>
            </a:r>
            <a:r>
              <a:rPr lang="cs-CZ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cs-CZ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C histology in early-</a:t>
            </a:r>
            <a:r>
              <a:rPr lang="cs-CZ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set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C </a:t>
            </a:r>
            <a:r>
              <a:rPr lang="cs-CZ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K2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PV </a:t>
            </a:r>
            <a:r>
              <a:rPr lang="cs-CZ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riers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cs-CZ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endParaRPr lang="cs-CZ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cs-CZ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Graf 11">
            <a:extLst>
              <a:ext uri="{FF2B5EF4-FFF2-40B4-BE49-F238E27FC236}">
                <a16:creationId xmlns:a16="http://schemas.microsoft.com/office/drawing/2014/main" id="{C3A1835A-FAE5-494F-94D6-01D5A0A1BA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1742156"/>
              </p:ext>
            </p:extLst>
          </p:nvPr>
        </p:nvGraphicFramePr>
        <p:xfrm>
          <a:off x="5986375" y="1511297"/>
          <a:ext cx="5772150" cy="36004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Obdélník 12">
            <a:extLst>
              <a:ext uri="{FF2B5EF4-FFF2-40B4-BE49-F238E27FC236}">
                <a16:creationId xmlns:a16="http://schemas.microsoft.com/office/drawing/2014/main" id="{A990B22C-73BD-48ED-883C-C7302973EABD}"/>
              </a:ext>
            </a:extLst>
          </p:cNvPr>
          <p:cNvSpPr/>
          <p:nvPr/>
        </p:nvSpPr>
        <p:spPr>
          <a:xfrm>
            <a:off x="2843490" y="4780103"/>
            <a:ext cx="808212" cy="58477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cs-CZ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K2</a:t>
            </a:r>
          </a:p>
        </p:txBody>
      </p:sp>
      <p:sp>
        <p:nvSpPr>
          <p:cNvPr id="14" name="Obdélník 13">
            <a:extLst>
              <a:ext uri="{FF2B5EF4-FFF2-40B4-BE49-F238E27FC236}">
                <a16:creationId xmlns:a16="http://schemas.microsoft.com/office/drawing/2014/main" id="{FB0F89E0-04AC-4EE8-919C-EF7DE8CD53D5}"/>
              </a:ext>
            </a:extLst>
          </p:cNvPr>
          <p:cNvSpPr/>
          <p:nvPr/>
        </p:nvSpPr>
        <p:spPr>
          <a:xfrm>
            <a:off x="1229681" y="1125242"/>
            <a:ext cx="468127" cy="3693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Obdélník 14">
            <a:extLst>
              <a:ext uri="{FF2B5EF4-FFF2-40B4-BE49-F238E27FC236}">
                <a16:creationId xmlns:a16="http://schemas.microsoft.com/office/drawing/2014/main" id="{3C5E7102-CE10-480A-A088-109F49510627}"/>
              </a:ext>
            </a:extLst>
          </p:cNvPr>
          <p:cNvSpPr/>
          <p:nvPr/>
        </p:nvSpPr>
        <p:spPr>
          <a:xfrm>
            <a:off x="6580396" y="1125242"/>
            <a:ext cx="468127" cy="3693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6" name="Obdélník 15">
            <a:extLst>
              <a:ext uri="{FF2B5EF4-FFF2-40B4-BE49-F238E27FC236}">
                <a16:creationId xmlns:a16="http://schemas.microsoft.com/office/drawing/2014/main" id="{A1D6AE89-DAE2-4C72-9575-D81665E8FFF2}"/>
              </a:ext>
            </a:extLst>
          </p:cNvPr>
          <p:cNvSpPr/>
          <p:nvPr/>
        </p:nvSpPr>
        <p:spPr>
          <a:xfrm>
            <a:off x="8736582" y="1882524"/>
            <a:ext cx="110128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cs-CZ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x CHEK2</a:t>
            </a:r>
          </a:p>
        </p:txBody>
      </p:sp>
      <p:sp>
        <p:nvSpPr>
          <p:cNvPr id="17" name="Obdélník 16">
            <a:extLst>
              <a:ext uri="{FF2B5EF4-FFF2-40B4-BE49-F238E27FC236}">
                <a16:creationId xmlns:a16="http://schemas.microsoft.com/office/drawing/2014/main" id="{7C0620C8-86B8-4AC8-AFD9-37FA0537EEB2}"/>
              </a:ext>
            </a:extLst>
          </p:cNvPr>
          <p:cNvSpPr/>
          <p:nvPr/>
        </p:nvSpPr>
        <p:spPr>
          <a:xfrm>
            <a:off x="7513464" y="2596739"/>
            <a:ext cx="110128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cs-CZ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x CHEK2</a:t>
            </a:r>
          </a:p>
        </p:txBody>
      </p:sp>
      <p:sp>
        <p:nvSpPr>
          <p:cNvPr id="18" name="Obdélník 17">
            <a:extLst>
              <a:ext uri="{FF2B5EF4-FFF2-40B4-BE49-F238E27FC236}">
                <a16:creationId xmlns:a16="http://schemas.microsoft.com/office/drawing/2014/main" id="{34F7F175-06E9-4D35-B73B-746263161494}"/>
              </a:ext>
            </a:extLst>
          </p:cNvPr>
          <p:cNvSpPr/>
          <p:nvPr/>
        </p:nvSpPr>
        <p:spPr>
          <a:xfrm>
            <a:off x="9405335" y="3797053"/>
            <a:ext cx="110128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cs-CZ" i="1" dirty="0">
                <a:solidFill>
                  <a:srgbClr val="99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x CHEK2</a:t>
            </a:r>
          </a:p>
        </p:txBody>
      </p:sp>
      <p:sp>
        <p:nvSpPr>
          <p:cNvPr id="19" name="Obdélník 18">
            <a:extLst>
              <a:ext uri="{FF2B5EF4-FFF2-40B4-BE49-F238E27FC236}">
                <a16:creationId xmlns:a16="http://schemas.microsoft.com/office/drawing/2014/main" id="{6A5A0CE1-9D76-4731-998A-FBF1FE83E924}"/>
              </a:ext>
            </a:extLst>
          </p:cNvPr>
          <p:cNvSpPr/>
          <p:nvPr/>
        </p:nvSpPr>
        <p:spPr>
          <a:xfrm>
            <a:off x="7713790" y="1094865"/>
            <a:ext cx="110128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cs-CZ" i="1" dirty="0">
                <a:solidFill>
                  <a:srgbClr val="BF9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x CHEK2</a:t>
            </a:r>
          </a:p>
        </p:txBody>
      </p:sp>
      <p:sp>
        <p:nvSpPr>
          <p:cNvPr id="20" name="Obdélník 19">
            <a:extLst>
              <a:ext uri="{FF2B5EF4-FFF2-40B4-BE49-F238E27FC236}">
                <a16:creationId xmlns:a16="http://schemas.microsoft.com/office/drawing/2014/main" id="{B86A8980-CBDB-4608-A2F9-7897C95E695E}"/>
              </a:ext>
            </a:extLst>
          </p:cNvPr>
          <p:cNvSpPr/>
          <p:nvPr/>
        </p:nvSpPr>
        <p:spPr>
          <a:xfrm>
            <a:off x="7939502" y="3404318"/>
            <a:ext cx="110128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cs-CZ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x CHEK2</a:t>
            </a:r>
          </a:p>
        </p:txBody>
      </p:sp>
      <p:sp>
        <p:nvSpPr>
          <p:cNvPr id="21" name="Obdélník 20">
            <a:extLst>
              <a:ext uri="{FF2B5EF4-FFF2-40B4-BE49-F238E27FC236}">
                <a16:creationId xmlns:a16="http://schemas.microsoft.com/office/drawing/2014/main" id="{7300E2B9-B51A-489A-B589-EDFF80C32DF0}"/>
              </a:ext>
            </a:extLst>
          </p:cNvPr>
          <p:cNvSpPr/>
          <p:nvPr/>
        </p:nvSpPr>
        <p:spPr>
          <a:xfrm>
            <a:off x="9164616" y="2554235"/>
            <a:ext cx="110128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cs-CZ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x CHEK2</a:t>
            </a:r>
          </a:p>
        </p:txBody>
      </p:sp>
      <p:sp>
        <p:nvSpPr>
          <p:cNvPr id="9" name="Obdélník 8">
            <a:extLst>
              <a:ext uri="{FF2B5EF4-FFF2-40B4-BE49-F238E27FC236}">
                <a16:creationId xmlns:a16="http://schemas.microsoft.com/office/drawing/2014/main" id="{234871F0-6511-4207-B954-FC4BC637BE1A}"/>
              </a:ext>
            </a:extLst>
          </p:cNvPr>
          <p:cNvSpPr/>
          <p:nvPr/>
        </p:nvSpPr>
        <p:spPr>
          <a:xfrm>
            <a:off x="1318154" y="4790810"/>
            <a:ext cx="2467198" cy="58477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 patients negative for HBOPC GPV</a:t>
            </a:r>
            <a:endParaRPr lang="cs-CZ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Obdélník 21">
            <a:extLst>
              <a:ext uri="{FF2B5EF4-FFF2-40B4-BE49-F238E27FC236}">
                <a16:creationId xmlns:a16="http://schemas.microsoft.com/office/drawing/2014/main" id="{BE9EB1BA-08CB-4A75-981D-6AD555F958C9}"/>
              </a:ext>
            </a:extLst>
          </p:cNvPr>
          <p:cNvSpPr/>
          <p:nvPr/>
        </p:nvSpPr>
        <p:spPr>
          <a:xfrm>
            <a:off x="3651702" y="4790810"/>
            <a:ext cx="2467199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cs-CZ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K2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PV </a:t>
            </a:r>
            <a:r>
              <a:rPr lang="cs-CZ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riers</a:t>
            </a:r>
            <a:endParaRPr lang="cs-CZ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Obdélník 22">
            <a:extLst>
              <a:ext uri="{FF2B5EF4-FFF2-40B4-BE49-F238E27FC236}">
                <a16:creationId xmlns:a16="http://schemas.microsoft.com/office/drawing/2014/main" id="{2484DE51-0644-4BC5-9A03-CC9BF7D6FAE2}"/>
              </a:ext>
            </a:extLst>
          </p:cNvPr>
          <p:cNvSpPr/>
          <p:nvPr/>
        </p:nvSpPr>
        <p:spPr>
          <a:xfrm>
            <a:off x="4412084" y="5066696"/>
            <a:ext cx="94755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</a:t>
            </a:r>
            <a:r>
              <a:rPr lang="cs-CZ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cs-CZ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Obdélník 23">
            <a:extLst>
              <a:ext uri="{FF2B5EF4-FFF2-40B4-BE49-F238E27FC236}">
                <a16:creationId xmlns:a16="http://schemas.microsoft.com/office/drawing/2014/main" id="{A2082ACB-4954-446D-B4D0-B85DD3BFA8F8}"/>
              </a:ext>
            </a:extLst>
          </p:cNvPr>
          <p:cNvSpPr/>
          <p:nvPr/>
        </p:nvSpPr>
        <p:spPr>
          <a:xfrm>
            <a:off x="0" y="6188971"/>
            <a:ext cx="12132001" cy="9746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BOPC,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reditary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east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varian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ncreatic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ncer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GPV,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rmline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thogenic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ariant; EOC,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pithelial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varian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ncer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LG,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w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rade; ser,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rous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mucin,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cinous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NA, not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vailable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m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dometrioid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HG,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gh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rade; BTO,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rderline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umor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vary.</a:t>
            </a:r>
          </a:p>
          <a:p>
            <a:pPr algn="just">
              <a:spcAft>
                <a:spcPts val="800"/>
              </a:spcAft>
            </a:pP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ly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C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tients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nown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ge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agnosis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</a:t>
            </a:r>
            <a:r>
              <a:rPr lang="cs-CZ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100" i="1" kern="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cluded</a:t>
            </a:r>
            <a:endParaRPr lang="cs-CZ" sz="1100" i="1" kern="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100" i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cs-CZ" sz="1100" kern="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28180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Obrázek 7">
            <a:extLst>
              <a:ext uri="{FF2B5EF4-FFF2-40B4-BE49-F238E27FC236}">
                <a16:creationId xmlns:a16="http://schemas.microsoft.com/office/drawing/2014/main" id="{6BA0D9D2-4590-4719-8ECB-2AF12FC22769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928026" y="800295"/>
            <a:ext cx="9133113" cy="5257409"/>
          </a:xfrm>
          <a:prstGeom prst="rect">
            <a:avLst/>
          </a:prstGeom>
        </p:spPr>
      </p:pic>
      <p:sp>
        <p:nvSpPr>
          <p:cNvPr id="5" name="Obdélník 4">
            <a:extLst>
              <a:ext uri="{FF2B5EF4-FFF2-40B4-BE49-F238E27FC236}">
                <a16:creationId xmlns:a16="http://schemas.microsoft.com/office/drawing/2014/main" id="{79C79C02-D3A0-418C-9B8E-16B5EAEDFE73}"/>
              </a:ext>
            </a:extLst>
          </p:cNvPr>
          <p:cNvSpPr/>
          <p:nvPr/>
        </p:nvSpPr>
        <p:spPr>
          <a:xfrm>
            <a:off x="113298" y="22258"/>
            <a:ext cx="11799127" cy="6155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3:</a:t>
            </a:r>
            <a:r>
              <a:rPr lang="en-US" sz="1600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olcano plot of gene sets enriched in overrepresentation analysis for disease in OMIM.</a:t>
            </a:r>
          </a:p>
          <a:p>
            <a:endParaRPr lang="cs-CZ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Obdélník 1">
            <a:extLst>
              <a:ext uri="{FF2B5EF4-FFF2-40B4-BE49-F238E27FC236}">
                <a16:creationId xmlns:a16="http://schemas.microsoft.com/office/drawing/2014/main" id="{518BBA45-158B-4CC9-95D3-6380BD346DAD}"/>
              </a:ext>
            </a:extLst>
          </p:cNvPr>
          <p:cNvSpPr/>
          <p:nvPr/>
        </p:nvSpPr>
        <p:spPr>
          <a:xfrm>
            <a:off x="8434448" y="718576"/>
            <a:ext cx="3253382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set 114480: Breast cancer </a:t>
            </a:r>
            <a:endParaRPr lang="cs-CZ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cs-CZ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ease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OMIM</a:t>
            </a:r>
            <a:endParaRPr lang="cs-CZ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-value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4.5×10</a:t>
            </a:r>
            <a:r>
              <a:rPr lang="en-US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0</a:t>
            </a:r>
            <a:endParaRPr lang="cs-CZ" sz="1600" baseline="30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DR 3×10</a:t>
            </a:r>
            <a:r>
              <a:rPr lang="en-US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9</a:t>
            </a:r>
            <a:endParaRPr lang="cs-CZ" sz="1600" baseline="30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48007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Obdélník 4">
            <a:extLst>
              <a:ext uri="{FF2B5EF4-FFF2-40B4-BE49-F238E27FC236}">
                <a16:creationId xmlns:a16="http://schemas.microsoft.com/office/drawing/2014/main" id="{79C79C02-D3A0-418C-9B8E-16B5EAEDFE73}"/>
              </a:ext>
            </a:extLst>
          </p:cNvPr>
          <p:cNvSpPr/>
          <p:nvPr/>
        </p:nvSpPr>
        <p:spPr>
          <a:xfrm>
            <a:off x="113298" y="22258"/>
            <a:ext cx="1179912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</a:t>
            </a:r>
            <a:r>
              <a:rPr lang="cs-CZ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600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relation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variables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ed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our study</a:t>
            </a:r>
            <a:endParaRPr lang="cs-CZ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Obrázek 2">
            <a:extLst>
              <a:ext uri="{FF2B5EF4-FFF2-40B4-BE49-F238E27FC236}">
                <a16:creationId xmlns:a16="http://schemas.microsoft.com/office/drawing/2014/main" id="{87790F86-5799-4FB4-995A-B777C44DC3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3921" y="1034549"/>
            <a:ext cx="5473124" cy="5042497"/>
          </a:xfrm>
          <a:prstGeom prst="rect">
            <a:avLst/>
          </a:prstGeom>
        </p:spPr>
      </p:pic>
      <p:sp>
        <p:nvSpPr>
          <p:cNvPr id="7" name="Obdélník 6">
            <a:extLst>
              <a:ext uri="{FF2B5EF4-FFF2-40B4-BE49-F238E27FC236}">
                <a16:creationId xmlns:a16="http://schemas.microsoft.com/office/drawing/2014/main" id="{829BAF7A-B6C6-4470-B793-C71C8A70F914}"/>
              </a:ext>
            </a:extLst>
          </p:cNvPr>
          <p:cNvSpPr/>
          <p:nvPr/>
        </p:nvSpPr>
        <p:spPr>
          <a:xfrm>
            <a:off x="113298" y="6067046"/>
            <a:ext cx="11995563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cs-CZ" sz="1400" dirty="0"/>
              <a:t>*HBOP genes</a:t>
            </a:r>
            <a:r>
              <a:rPr lang="cs-CZ" sz="1400" i="1" dirty="0"/>
              <a:t>: ATM, BARD1, BRCA1, BRCA2, BRIP1, CDH1, CDKN2A, CHEK2, MLH1, MSH2/EPCAM, MSH6, NF1, PALB2, PMS2, PTEN, RAD51C/D, STK11, and TP53 </a:t>
            </a:r>
          </a:p>
          <a:p>
            <a:r>
              <a:rPr lang="cs-CZ" sz="1400" i="1" dirty="0"/>
              <a:t>**</a:t>
            </a:r>
            <a:r>
              <a:rPr lang="en-US" sz="1400" i="1" dirty="0"/>
              <a:t>Hovhannisyan, M. et al. Population-specific validation and comparison of the performance of 77- and 313-variant polygenic risk scores for breast cancer risk prediction. Cancer, doi:10.1002/cncr.35337 (2024).</a:t>
            </a:r>
            <a:endParaRPr lang="cs-CZ" sz="1400" i="1" dirty="0"/>
          </a:p>
        </p:txBody>
      </p:sp>
      <p:sp>
        <p:nvSpPr>
          <p:cNvPr id="9" name="TextovéPole 8">
            <a:extLst>
              <a:ext uri="{FF2B5EF4-FFF2-40B4-BE49-F238E27FC236}">
                <a16:creationId xmlns:a16="http://schemas.microsoft.com/office/drawing/2014/main" id="{6E8C5E37-EB2F-40BE-A71F-F698F8CFFB77}"/>
              </a:ext>
            </a:extLst>
          </p:cNvPr>
          <p:cNvSpPr txBox="1"/>
          <p:nvPr/>
        </p:nvSpPr>
        <p:spPr>
          <a:xfrm>
            <a:off x="2749338" y="177970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/>
              <a:t>*</a:t>
            </a:r>
          </a:p>
        </p:txBody>
      </p:sp>
      <p:sp>
        <p:nvSpPr>
          <p:cNvPr id="10" name="TextovéPole 9">
            <a:extLst>
              <a:ext uri="{FF2B5EF4-FFF2-40B4-BE49-F238E27FC236}">
                <a16:creationId xmlns:a16="http://schemas.microsoft.com/office/drawing/2014/main" id="{5A2BB030-39EA-44F8-9C65-18CE27FBF4BD}"/>
              </a:ext>
            </a:extLst>
          </p:cNvPr>
          <p:cNvSpPr txBox="1"/>
          <p:nvPr/>
        </p:nvSpPr>
        <p:spPr>
          <a:xfrm rot="19818908">
            <a:off x="7367647" y="495146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612096261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</TotalTime>
  <Words>426</Words>
  <Application>Microsoft Office PowerPoint</Application>
  <PresentationFormat>Širokoúhlá obrazovka</PresentationFormat>
  <Paragraphs>48</Paragraphs>
  <Slides>4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4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Motiv Office</vt:lpstr>
      <vt:lpstr>Prezentace aplikace PowerPoint</vt:lpstr>
      <vt:lpstr>Prezentace aplikace PowerPoint</vt:lpstr>
      <vt:lpstr>Prezentace aplikace PowerPoint</vt:lpstr>
      <vt:lpstr>Prezentace aplikac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Horáčková Klára, Mgr.</dc:creator>
  <cp:lastModifiedBy>Jana Soukupová</cp:lastModifiedBy>
  <cp:revision>97</cp:revision>
  <dcterms:created xsi:type="dcterms:W3CDTF">2023-12-05T13:17:09Z</dcterms:created>
  <dcterms:modified xsi:type="dcterms:W3CDTF">2024-06-11T12:22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2063cd7f-2d21-486a-9f29-9c1683fdd175_Enabled">
    <vt:lpwstr>true</vt:lpwstr>
  </property>
  <property fmtid="{D5CDD505-2E9C-101B-9397-08002B2CF9AE}" pid="3" name="MSIP_Label_2063cd7f-2d21-486a-9f29-9c1683fdd175_SetDate">
    <vt:lpwstr>2023-12-05T14:16:41Z</vt:lpwstr>
  </property>
  <property fmtid="{D5CDD505-2E9C-101B-9397-08002B2CF9AE}" pid="4" name="MSIP_Label_2063cd7f-2d21-486a-9f29-9c1683fdd175_Method">
    <vt:lpwstr>Standard</vt:lpwstr>
  </property>
  <property fmtid="{D5CDD505-2E9C-101B-9397-08002B2CF9AE}" pid="5" name="MSIP_Label_2063cd7f-2d21-486a-9f29-9c1683fdd175_Name">
    <vt:lpwstr>2063cd7f-2d21-486a-9f29-9c1683fdd175</vt:lpwstr>
  </property>
  <property fmtid="{D5CDD505-2E9C-101B-9397-08002B2CF9AE}" pid="6" name="MSIP_Label_2063cd7f-2d21-486a-9f29-9c1683fdd175_SiteId">
    <vt:lpwstr>0f277086-d4e0-4971-bc1a-bbc5df0eb246</vt:lpwstr>
  </property>
  <property fmtid="{D5CDD505-2E9C-101B-9397-08002B2CF9AE}" pid="7" name="MSIP_Label_2063cd7f-2d21-486a-9f29-9c1683fdd175_ActionId">
    <vt:lpwstr>a80cd589-b55b-4280-a8ea-d763f75fa2f4</vt:lpwstr>
  </property>
  <property fmtid="{D5CDD505-2E9C-101B-9397-08002B2CF9AE}" pid="8" name="MSIP_Label_2063cd7f-2d21-486a-9f29-9c1683fdd175_ContentBits">
    <vt:lpwstr>0</vt:lpwstr>
  </property>
</Properties>
</file>